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586"/>
  </p:normalViewPr>
  <p:slideViewPr>
    <p:cSldViewPr snapToGrid="0" snapToObjects="1">
      <p:cViewPr varScale="1">
        <p:scale>
          <a:sx n="104" d="100"/>
          <a:sy n="104" d="100"/>
        </p:scale>
        <p:origin x="8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30988F-B65D-6547-AA90-8FB83E2BA3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F6C808-331D-9247-A7EB-3E49C4ABBF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50E489-D7E7-DD4A-945F-77CC36B1F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E0B7AB-B6BC-8342-AABF-3CA5AC276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35B16-C00F-884D-967B-595EEC574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080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CADC9-103E-0A42-B777-EDA90AB994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919484-D20F-3941-9D6B-261A91B144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8EF7B3-9E1D-1E43-B2C8-532701F6B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4FDCA-EA36-C949-AEE1-402FEEF85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3876A-D323-C542-AE68-9A8821CD5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5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104405-CFB7-6243-AEC4-E637BB7B5A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7B1F42-DAEE-3346-A6ED-8C1F4716DD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01BEA-AA04-CD49-9D2B-52A4E6F759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FF1-5E7F-1042-B67E-D4F0D245C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C152C-CB8C-5A41-A550-C9C5DCB5E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721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E47BD-36C8-8B47-BD05-62B76ACA17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1AA293-75D6-F14D-AB35-BF93B4834C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7B65CE-9128-514F-A5EF-9172290A1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86EAB-32E1-9E4E-946E-FBB3AC0AE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1509FD-A044-1448-9819-3F9CBB234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236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20596-7412-B042-9BD1-625D0B799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2BCA2F-092F-A047-8CAC-A1213257BA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2476D4-8387-6A40-AA38-98DD25F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F418F-D9FD-3440-B664-B453C4609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5FD84-0DAB-B041-8A38-C84FB3804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49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4F5F9-22D1-F247-AE9F-B1CB5236AB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A6D557-F5A8-2E41-B04C-68918AF511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720983-7568-8B45-9F60-B4660A60B7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27626B-AE9C-1340-B012-E69FAAB33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DE671D-A1FD-174A-9584-BF98759D6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E5291C-D087-F34E-BEFB-FDBA7B8C8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675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CB0C7-BDF7-9241-8584-D1FDAACF53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E34854-8223-B94B-AD87-8003952D8A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B2CE8F-F0DC-714C-8EB5-1B2C0D0A98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CF5DF4-D02D-0649-9D96-AA9AD099CA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7372A9-F820-874D-9421-45F29F5B4C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4188E8-FAC8-8A4F-8980-E5A99940F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D92CAF-0346-7C41-A5FB-33933E613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D2AE70-4A5D-E247-B5F7-7FAFD9C0E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846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BB302-CCE3-E341-95C1-0E22E2A19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F05AE4-79EF-A349-8B93-2AB5C8F87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0BF56F-7815-9D46-95C1-CB38FE34C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B56E56-8C16-0F45-A0A8-3B67706FB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993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861FD1-9702-7249-A664-3E8EA2935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25D264-B3BC-E74E-A494-3AA0E16A7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D11313-5727-0F41-BE5D-91AFCC9A0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305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1B1F1-7A0C-A141-BE72-613D92728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F9DC9B-51CF-2E47-9461-04D4821803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16BC45-FFD1-EF43-9EE1-DA2E4029D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37785B-0329-2C4E-90A4-BCF37DC4A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1C7D92-6987-AF4E-A468-9534430F3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6D05F6-F12D-C943-81BD-3B7E74312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28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600D8-EC3F-9745-BD9F-9462A09E7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1EDC70-E0C4-F244-BF38-229A76E30E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E8CFC3-C40B-3C45-8768-CEB68D5B0A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B88937-AB09-CA4C-894E-33062F5A4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3CC1A3-5003-CA49-A180-5D7E9B39E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5CF1E7-15FD-2341-B541-3285D9962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754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1C39C6-96C1-264F-BD38-CE5D32ADB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07B366-50AB-7841-A5BE-6B6C99D5E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1829E0-EFF2-8D44-AFDC-86DE10A8F0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96784-D872-A849-9AE1-06A90A4CB29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14F6B7-B80D-CB4E-BAB1-3B3102FD16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975347-4B9C-5C44-87FA-FDB0B50362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CFD2F-3697-1340-9B77-E8FE215904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326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13952BD-65E1-C748-8054-9317D70554A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99" t="12888" r="13799" b="1100"/>
          <a:stretch/>
        </p:blipFill>
        <p:spPr>
          <a:xfrm>
            <a:off x="140678" y="2667199"/>
            <a:ext cx="5592857" cy="40253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7965205-2832-5542-88A4-C6226C3325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3" t="13861" r="13759" b="943"/>
          <a:stretch/>
        </p:blipFill>
        <p:spPr>
          <a:xfrm>
            <a:off x="6458467" y="2796669"/>
            <a:ext cx="5455563" cy="389588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7578656-C56C-C74D-903F-BBFF27993C03}"/>
              </a:ext>
            </a:extLst>
          </p:cNvPr>
          <p:cNvSpPr txBox="1"/>
          <p:nvPr/>
        </p:nvSpPr>
        <p:spPr>
          <a:xfrm>
            <a:off x="2113005" y="2020868"/>
            <a:ext cx="12538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rGRP78</a:t>
            </a:r>
          </a:p>
          <a:p>
            <a:pPr algn="ctr"/>
            <a:r>
              <a:rPr lang="en-US" b="1" dirty="0"/>
              <a:t>lot#13031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D9E032-AD2E-3E43-89D2-ECEB27EE22AA}"/>
              </a:ext>
            </a:extLst>
          </p:cNvPr>
          <p:cNvSpPr txBox="1"/>
          <p:nvPr/>
        </p:nvSpPr>
        <p:spPr>
          <a:xfrm>
            <a:off x="8476577" y="2150338"/>
            <a:ext cx="1064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in-house </a:t>
            </a:r>
          </a:p>
          <a:p>
            <a:pPr algn="ctr"/>
            <a:r>
              <a:rPr lang="en-US" b="1" dirty="0"/>
              <a:t>rGRP7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82420E-B477-3247-947E-3DE9C913A6FC}"/>
              </a:ext>
            </a:extLst>
          </p:cNvPr>
          <p:cNvSpPr txBox="1"/>
          <p:nvPr/>
        </p:nvSpPr>
        <p:spPr>
          <a:xfrm>
            <a:off x="0" y="-37344"/>
            <a:ext cx="8999771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5: </a:t>
            </a:r>
          </a:p>
          <a:p>
            <a:r>
              <a:rPr lang="en-US" sz="1400" dirty="0"/>
              <a:t>An example of a side-by side comparison between the locations of various PTMs. This shows</a:t>
            </a:r>
          </a:p>
          <a:p>
            <a:r>
              <a:rPr lang="en-US" sz="1400" dirty="0"/>
              <a:t>that in general, the PTMs locations generally do not differ between different rGRP78 preparation.</a:t>
            </a:r>
          </a:p>
          <a:p>
            <a:endParaRPr lang="en-US" sz="1400" dirty="0"/>
          </a:p>
          <a:p>
            <a:r>
              <a:rPr lang="en-US" sz="1400" b="1" dirty="0"/>
              <a:t>note: </a:t>
            </a:r>
            <a:r>
              <a:rPr lang="en-US" sz="1400" dirty="0"/>
              <a:t>The yellow highlight shows the MS peptide coverage under trypsin digestion.</a:t>
            </a:r>
          </a:p>
          <a:p>
            <a:r>
              <a:rPr lang="en-US" sz="1400" dirty="0"/>
              <a:t>The green circle (filled or unfilled) encodes for different confidence levels when assigning a modification to a specific site.</a:t>
            </a:r>
          </a:p>
          <a:p>
            <a:r>
              <a:rPr lang="en-US" sz="1400" dirty="0"/>
              <a:t>(filled &gt; unfilled in confidence level)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C8FDCC-F4DA-014B-AD0B-BF306078DD15}"/>
              </a:ext>
            </a:extLst>
          </p:cNvPr>
          <p:cNvSpPr txBox="1"/>
          <p:nvPr/>
        </p:nvSpPr>
        <p:spPr>
          <a:xfrm>
            <a:off x="10079062" y="15547"/>
            <a:ext cx="1963038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o: oxidation</a:t>
            </a:r>
          </a:p>
          <a:p>
            <a:r>
              <a:rPr lang="en-US" dirty="0"/>
              <a:t>d: deamidation</a:t>
            </a:r>
          </a:p>
          <a:p>
            <a:r>
              <a:rPr lang="en-US" dirty="0"/>
              <a:t>p: phosphorylation</a:t>
            </a:r>
          </a:p>
          <a:p>
            <a:r>
              <a:rPr lang="en-US" dirty="0"/>
              <a:t>c: citrullination</a:t>
            </a:r>
          </a:p>
        </p:txBody>
      </p:sp>
    </p:spTree>
    <p:extLst>
      <p:ext uri="{BB962C8B-B14F-4D97-AF65-F5344CB8AC3E}">
        <p14:creationId xmlns:p14="http://schemas.microsoft.com/office/powerpoint/2010/main" val="380816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97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5</cp:revision>
  <cp:lastPrinted>2020-10-02T21:51:27Z</cp:lastPrinted>
  <dcterms:created xsi:type="dcterms:W3CDTF">2020-06-24T18:04:38Z</dcterms:created>
  <dcterms:modified xsi:type="dcterms:W3CDTF">2020-10-02T21:51:30Z</dcterms:modified>
</cp:coreProperties>
</file>